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sldIdLst>
    <p:sldId id="258" r:id="rId3"/>
    <p:sldId id="280" r:id="rId4"/>
    <p:sldId id="277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9" r:id="rId14"/>
    <p:sldId id="270" r:id="rId15"/>
    <p:sldId id="271" r:id="rId16"/>
    <p:sldId id="272" r:id="rId17"/>
    <p:sldId id="273" r:id="rId1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02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 varScale="1">
        <p:scale>
          <a:sx n="76" d="100"/>
          <a:sy n="76" d="100"/>
        </p:scale>
        <p:origin x="432" y="78"/>
      </p:cViewPr>
      <p:guideLst>
        <p:guide orient="horz" pos="2160"/>
        <p:guide pos="302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slide" Target="slides/slide11.xml"/><Relationship Id="rId18" Type="http://schemas.openxmlformats.org/officeDocument/2006/relationships/slide" Target="slides/slide16.xml"/><Relationship Id="rId3" Type="http://schemas.openxmlformats.org/officeDocument/2006/relationships/slide" Target="slides/slide1.xml"/><Relationship Id="rId21" Type="http://schemas.openxmlformats.org/officeDocument/2006/relationships/theme" Target="theme/theme1.xml"/><Relationship Id="rId7" Type="http://schemas.openxmlformats.org/officeDocument/2006/relationships/slide" Target="slides/slide5.xml"/><Relationship Id="rId12" Type="http://schemas.openxmlformats.org/officeDocument/2006/relationships/slide" Target="slides/slide10.xml"/><Relationship Id="rId17" Type="http://schemas.openxmlformats.org/officeDocument/2006/relationships/slide" Target="slides/slide15.xml"/><Relationship Id="rId2" Type="http://schemas.openxmlformats.org/officeDocument/2006/relationships/slideMaster" Target="slideMasters/slideMaster2.xml"/><Relationship Id="rId16" Type="http://schemas.openxmlformats.org/officeDocument/2006/relationships/slide" Target="slides/slide14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slide" Target="slides/slide9.xml"/><Relationship Id="rId5" Type="http://schemas.openxmlformats.org/officeDocument/2006/relationships/slide" Target="slides/slide3.xml"/><Relationship Id="rId15" Type="http://schemas.openxmlformats.org/officeDocument/2006/relationships/slide" Target="slides/slide13.xml"/><Relationship Id="rId10" Type="http://schemas.openxmlformats.org/officeDocument/2006/relationships/slide" Target="slides/slide8.xml"/><Relationship Id="rId19" Type="http://schemas.openxmlformats.org/officeDocument/2006/relationships/presProps" Target="presProps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slide" Target="slides/slide12.xml"/><Relationship Id="rId22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005D8E-25DC-449D-B407-BB3C177EFFE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F4190BF-4EFA-44FF-A913-94F623231EF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427BAD-414C-49C2-A00B-5E0CF1F046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68C62-A60A-49B7-B7F1-AB3C35B634D6}" type="datetimeFigureOut">
              <a:rPr lang="en-US" smtClean="0"/>
              <a:t>6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28492A-0A24-4A50-BA28-F653B7C930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56AD80-72E0-4A24-8666-D2E3D419D1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C0C66-0E14-4E4D-9D74-B3B3C312D1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32479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5D9D55-978B-4C31-8F1F-A30647C2EE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2A707C9-D5E1-465C-AFD9-025D6816BC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908A98-DE5B-4955-A5C0-10175C40E3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68C62-A60A-49B7-B7F1-AB3C35B634D6}" type="datetimeFigureOut">
              <a:rPr lang="en-US" smtClean="0"/>
              <a:t>6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2B28B0-A831-421A-971F-38D0A51197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E89AD0-EC54-4C13-A3E8-D5A4E072D1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C0C66-0E14-4E4D-9D74-B3B3C312D1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68558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A97EAF1-596C-432F-B67C-DAF75557991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53BF7A9-AFB2-4E43-B003-590D28898F4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8E80D5-E84A-4723-9FA4-C472DA38B5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68C62-A60A-49B7-B7F1-AB3C35B634D6}" type="datetimeFigureOut">
              <a:rPr lang="en-US" smtClean="0"/>
              <a:t>6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0F148F-DA9D-41D7-AC9F-CF31D0886B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1730D0-A7FD-4E89-A77F-F287E20006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C0C66-0E14-4E4D-9D74-B3B3C312D1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4695713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F9421B-1B75-48F2-8CE0-686E3394C58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165A0AA-1A51-4C71-8201-CF1236E6EBE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404688-C936-4E95-9E5F-07CC66E45B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BDC40-4B5B-49E2-87E4-043DC21C55A0}" type="datetimeFigureOut">
              <a:rPr lang="en-US" smtClean="0"/>
              <a:t>6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1032AF-6022-4C1B-8739-45CDA79F5D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B4BDA4-44E8-4067-B648-8F5B8E82A5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7E25-0AFE-4D2E-993D-4ACD09864B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4626670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E9D0B9-1EC0-4EF5-9564-E62E35583F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1D587AA-6369-404B-8AAD-4078B4864C3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733FA2-6FEF-4147-8C17-49345E00E8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BDC40-4B5B-49E2-87E4-043DC21C55A0}" type="datetimeFigureOut">
              <a:rPr lang="en-US" smtClean="0"/>
              <a:t>6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56D7B9-C6A4-4C2F-A891-86ADD4241C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059AD4-8E0B-4FE7-9C03-75F61401C4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7E25-0AFE-4D2E-993D-4ACD09864B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771393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A1444C-F05E-455C-A68C-1CEC23A750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EFDD0C2-DFFE-4147-B44A-3AC469403F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B6124D-1400-4D6A-884C-C783F1C308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BDC40-4B5B-49E2-87E4-043DC21C55A0}" type="datetimeFigureOut">
              <a:rPr lang="en-US" smtClean="0"/>
              <a:t>6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ED5317-DE6F-4E15-BB59-D07E78915C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BF4D55-4452-4B23-A6E5-2545CCADBF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7E25-0AFE-4D2E-993D-4ACD09864B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0212923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5B9A1F-68EB-4365-A2B5-EC541B0F95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10912F7-D646-4ED7-A6E9-26E1956CC43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FE15A11-E336-4FB2-B444-60D9DC0B922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5F01449-50C0-4CC6-9650-EC87322442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BDC40-4B5B-49E2-87E4-043DC21C55A0}" type="datetimeFigureOut">
              <a:rPr lang="en-US" smtClean="0"/>
              <a:t>6/1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820C902-6025-457C-BC7B-58A748B277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405EB88-4444-4465-B2AB-F02E8546AE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7E25-0AFE-4D2E-993D-4ACD09864B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364015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D472D9-E390-409F-9667-5C5870A9C2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F5F5110-E0A8-4265-B1DB-A556442746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B052DD8-634A-4B4B-9E32-809D37FFEB8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867C0A9-89F0-44E8-83D0-AE24620974C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58A94FF-5009-49D3-BA90-799B78A8C1C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D25C76A-7021-42DE-8BB8-8699DCBA27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BDC40-4B5B-49E2-87E4-043DC21C55A0}" type="datetimeFigureOut">
              <a:rPr lang="en-US" smtClean="0"/>
              <a:t>6/14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DC5EC4F-B826-4714-81AE-A6F236193C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BB91EBE-826F-43BB-A625-33C784C90B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7E25-0AFE-4D2E-993D-4ACD09864B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8882238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5750F6-7EDF-456F-A168-8F9EFF37F8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02CC764-943B-4E81-A460-CDF5F92B2D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BDC40-4B5B-49E2-87E4-043DC21C55A0}" type="datetimeFigureOut">
              <a:rPr lang="en-US" smtClean="0"/>
              <a:t>6/14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8C00027-1505-40E3-BFCB-5E3379048A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EA67F3E-3CDB-4BD8-9776-D843F51AFA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7E25-0AFE-4D2E-993D-4ACD09864B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798929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C79C3F2-DC3C-4ACF-83E7-2DF1829CA8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BDC40-4B5B-49E2-87E4-043DC21C55A0}" type="datetimeFigureOut">
              <a:rPr lang="en-US" smtClean="0"/>
              <a:t>6/14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1DF455E-7C15-403D-B84B-AA0506202C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BBB6099-6CAC-4E37-ADAB-D15D525F4F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7E25-0AFE-4D2E-993D-4ACD09864B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132623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C6D148-C768-4B0B-ACD2-D968D72BFF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81903EF-FD1D-489A-9F4B-22F8BB06EFB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A829B97-786F-4FD6-AE1B-2C4B2C0089B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1BCC518-88C9-4FFD-B814-6E47C56AEB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BDC40-4B5B-49E2-87E4-043DC21C55A0}" type="datetimeFigureOut">
              <a:rPr lang="en-US" smtClean="0"/>
              <a:t>6/1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4046DA7-CB90-4E3B-824E-FC6C15A0FE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A25DFE-A392-4390-88A7-377BD0CB5A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7E25-0AFE-4D2E-993D-4ACD09864B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85581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5A6048-582B-4DDE-BBB6-8A68840CB7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6ADEF3E-D5E3-4974-8CC9-7404F761306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422744-F799-4651-BDA6-BBEEF26D04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68C62-A60A-49B7-B7F1-AB3C35B634D6}" type="datetimeFigureOut">
              <a:rPr lang="en-US" smtClean="0"/>
              <a:t>6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CB6DB5-D507-4AFD-A12C-3A5079C0DA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AF2932-AFF9-4BA3-A3A6-EDF0D01AFB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C0C66-0E14-4E4D-9D74-B3B3C312D1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2330813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282140-A4A7-49A8-A873-17C3618226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D0C6DFB-BC1D-421C-9AF5-04FF9CAAAB8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DEFBFC7-C5FE-4B52-9202-B29EBF91D66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623BA24-59BD-4D1D-8843-7CE8D49734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BDC40-4B5B-49E2-87E4-043DC21C55A0}" type="datetimeFigureOut">
              <a:rPr lang="en-US" smtClean="0"/>
              <a:t>6/1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B176064-63B5-4153-B8BA-41C776268F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829368D-DC3E-467C-AF07-AA4142D9AF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7E25-0AFE-4D2E-993D-4ACD09864B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2216990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6AF5BF-BAAB-4E49-B69E-612117E18C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9FDDCBC-1145-43D0-9EAE-0B1041E7C62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F051E5-30AF-49BE-AAD7-E774E4AFCB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BDC40-4B5B-49E2-87E4-043DC21C55A0}" type="datetimeFigureOut">
              <a:rPr lang="en-US" smtClean="0"/>
              <a:t>6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7C1B29-7FBB-4C96-A463-D72728672C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CDE012-A36C-4949-87C1-3242558083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7E25-0AFE-4D2E-993D-4ACD09864B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4920496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E1176E5-FCD9-48D9-8EB9-59B6AD539DC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1D274B0-FDC3-4766-B1C4-CD726DD21B6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8E14C5-7027-4AAB-A93F-B942F4E110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BDC40-4B5B-49E2-87E4-043DC21C55A0}" type="datetimeFigureOut">
              <a:rPr lang="en-US" smtClean="0"/>
              <a:t>6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F22D19-A72E-4C31-985B-8BC522D3B0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0F1348-BFBE-4248-AF20-4456E258B4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407E25-0AFE-4D2E-993D-4ACD09864B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20661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20DAFF-A42F-464C-AB09-6E3CE22E2B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17FD2C6-ABF4-4876-BE6D-BD760CBFDD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895A71-B507-46F9-8D07-1DB9617391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68C62-A60A-49B7-B7F1-AB3C35B634D6}" type="datetimeFigureOut">
              <a:rPr lang="en-US" smtClean="0"/>
              <a:t>6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20754A-2F77-489C-8DBF-241C40CBFF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C2AC23-979C-41A7-B745-891C65EC85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C0C66-0E14-4E4D-9D74-B3B3C312D1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13373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EE6E64-7196-4749-9B6B-8843626102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E9457E6-9555-4BFE-B562-D91D7CC43B7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3D4D779-8565-4F6C-A7E7-E3D287F4AF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4480338-61AF-4602-A2BA-FAB114E989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68C62-A60A-49B7-B7F1-AB3C35B634D6}" type="datetimeFigureOut">
              <a:rPr lang="en-US" smtClean="0"/>
              <a:t>6/1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9B1E580-F60E-4861-AA58-5B6A4E99BB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80CDAE4-4401-43AD-908C-F1E2E7E5CE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C0C66-0E14-4E4D-9D74-B3B3C312D1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85598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D2145D-DA55-4F1E-B6CC-1E2E7123E0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780667E-C06F-4929-A1FF-9EF5EBA5677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444AA47-4A6A-4BD8-AC15-8A4C592DA13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B713EBC-F5F6-4540-B8EB-0EABA1AA3E1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F1F8D26-FB4A-490F-9AA5-F71E4CD55AC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ADA9617-3610-468D-B758-ED27AFEE43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68C62-A60A-49B7-B7F1-AB3C35B634D6}" type="datetimeFigureOut">
              <a:rPr lang="en-US" smtClean="0"/>
              <a:t>6/14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3E21B5D-1FF9-4C34-983E-269E3E1CB7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09A8CD8-95EA-4A06-9046-2C73DC694B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C0C66-0E14-4E4D-9D74-B3B3C312D1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60463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16342B-8488-4953-934E-B45B714B98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24EC4ED-E83E-4E06-BDFF-9F3153F294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68C62-A60A-49B7-B7F1-AB3C35B634D6}" type="datetimeFigureOut">
              <a:rPr lang="en-US" smtClean="0"/>
              <a:t>6/14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FEBB131-A729-4A89-B4D2-7A1F82DF34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18EC832-D96F-49AD-8330-2BD223A8A3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C0C66-0E14-4E4D-9D74-B3B3C312D1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05589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009ACB9-F389-423E-899E-C50AB456CE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68C62-A60A-49B7-B7F1-AB3C35B634D6}" type="datetimeFigureOut">
              <a:rPr lang="en-US" smtClean="0"/>
              <a:t>6/14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63BB7F2-B043-4E68-B192-B556307347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0C37C98-6B19-4328-9EAF-69BD75218E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C0C66-0E14-4E4D-9D74-B3B3C312D1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68229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55898A-21DE-4FD0-AAE5-DD4C133504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2CA52EF-8276-4771-87BB-E7C731AFD3B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3C1A6BC-59A2-486B-94C0-E0E3CC49AAC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111983E-0BE5-49B3-8A96-330B52AA4E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68C62-A60A-49B7-B7F1-AB3C35B634D6}" type="datetimeFigureOut">
              <a:rPr lang="en-US" smtClean="0"/>
              <a:t>6/1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D6E8E24-E5A6-4E8C-BDD5-7533412679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8F55BFB-19DE-4D38-8715-F32CCF59F8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C0C66-0E14-4E4D-9D74-B3B3C312D1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04281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E36D13-1429-4031-A2A1-4381C93DC6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3C9ED99-5D57-428D-9712-DCB6A40F543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B01A2F3-B258-420F-9FA6-454BFF0A00C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0D54EAE-0B1A-438F-BC85-EAA73FEFEE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F68C62-A60A-49B7-B7F1-AB3C35B634D6}" type="datetimeFigureOut">
              <a:rPr lang="en-US" smtClean="0"/>
              <a:t>6/14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2D752EA-3052-4668-A642-A6D2D9990E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1A89AE4-59C3-4AA7-872A-5BE213AAD3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4C0C66-0E14-4E4D-9D74-B3B3C312D1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67159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15CE8D1-3ADD-4ABF-8B8B-9844C953B3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A22F31D-038A-4A4D-B9AF-5A50234334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9B0487-548C-4E8F-8FE7-617070731AE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F68C62-A60A-49B7-B7F1-AB3C35B634D6}" type="datetimeFigureOut">
              <a:rPr lang="en-US" smtClean="0"/>
              <a:t>6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F243E5-286B-4EF5-AA6B-319AFD010CF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202DBB-F2C4-444E-910D-D96CCAB6A85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4C0C66-0E14-4E4D-9D74-B3B3C312D1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25583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5BBF492-52E1-4588-B265-C459F4D4A5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C6D8339-E0A5-464D-9805-F55A52A259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398B50-DFE9-462C-A843-6D2DEEAD66C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5BDC40-4B5B-49E2-87E4-043DC21C55A0}" type="datetimeFigureOut">
              <a:rPr lang="en-US" smtClean="0"/>
              <a:t>6/14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EB9FB1-7C42-44D1-AC3A-67072B57B6B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BA5F3A-0B7D-4D3B-A751-EB1A1D3229D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407E25-0AFE-4D2E-993D-4ACD09864B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57277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748218-183C-4EE3-894E-C83B5BD1D5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etup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CC399C6A-67C5-4E41-A436-A6DADEFC4A2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4337" y="1545967"/>
            <a:ext cx="8351971" cy="4630996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8594C90A-E80D-43B1-959A-B999FE5367F0}"/>
              </a:ext>
            </a:extLst>
          </p:cNvPr>
          <p:cNvSpPr txBox="1"/>
          <p:nvPr/>
        </p:nvSpPr>
        <p:spPr>
          <a:xfrm>
            <a:off x="8714874" y="2065032"/>
            <a:ext cx="2763253" cy="37856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1">
              <a:spcBef>
                <a:spcPts val="0"/>
              </a:spcBef>
              <a:spcAft>
                <a:spcPts val="0"/>
              </a:spcAft>
              <a:tabLst>
                <a:tab pos="914400" algn="l"/>
              </a:tabLst>
            </a:pPr>
            <a:r>
              <a:rPr lang="en-US" sz="1200" b="1" dirty="0"/>
              <a:t>Matrix Spray</a:t>
            </a:r>
          </a:p>
          <a:p>
            <a:pPr marL="171450" marR="0" lvl="1" indent="-171450"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Char char="•"/>
              <a:tabLst>
                <a:tab pos="914400" algn="l"/>
              </a:tabLst>
            </a:pPr>
            <a:r>
              <a:rPr lang="en-US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10 mg/mL of DAN in 70% ACN in 0.1% TFA with 4 passes at 30C, 0.1 mL/min flow rate, 1200 mm/min track velocity, 2.5 mm track spacing, CC pattern, 10 psi pressure, 2 L/min gas flow rate, 0s dry time, 40 mm nozzle height.</a:t>
            </a:r>
          </a:p>
          <a:p>
            <a:pPr marL="0" marR="0" lvl="1">
              <a:spcBef>
                <a:spcPts val="0"/>
              </a:spcBef>
              <a:spcAft>
                <a:spcPts val="0"/>
              </a:spcAft>
              <a:tabLst>
                <a:tab pos="914400" algn="l"/>
              </a:tabLst>
            </a:pPr>
            <a:endParaRPr lang="en-US" sz="1200" dirty="0">
              <a:solidFill>
                <a:srgbClr val="000000"/>
              </a:solidFill>
              <a:latin typeface="Calibri" panose="020F0502020204030204" pitchFamily="34" charset="0"/>
              <a:ea typeface="DengXian" panose="02010600030101010101" pitchFamily="2" charset="-122"/>
            </a:endParaRPr>
          </a:p>
          <a:p>
            <a:pPr marL="0" marR="0" lvl="1">
              <a:spcBef>
                <a:spcPts val="0"/>
              </a:spcBef>
              <a:spcAft>
                <a:spcPts val="0"/>
              </a:spcAft>
              <a:tabLst>
                <a:tab pos="914400" algn="l"/>
              </a:tabLst>
            </a:pPr>
            <a:r>
              <a:rPr lang="en-US" sz="1200" b="1" dirty="0">
                <a:solidFill>
                  <a:srgbClr val="000000"/>
                </a:solidFill>
                <a:latin typeface="Calibri" panose="020F0502020204030204" pitchFamily="34" charset="0"/>
                <a:ea typeface="DengXian" panose="02010600030101010101" pitchFamily="2" charset="-122"/>
              </a:rPr>
              <a:t>Instrument</a:t>
            </a:r>
          </a:p>
          <a:p>
            <a:pPr marL="171450" marR="0" lvl="1" indent="-171450"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Char char="•"/>
              <a:tabLst>
                <a:tab pos="914400" algn="l"/>
              </a:tabLst>
            </a:pPr>
            <a:r>
              <a:rPr lang="en-US" sz="1200" dirty="0" err="1">
                <a:solidFill>
                  <a:srgbClr val="000000"/>
                </a:solidFill>
                <a:latin typeface="Calibri" panose="020F0502020204030204" pitchFamily="34" charset="0"/>
                <a:ea typeface="DengXian" panose="02010600030101010101" pitchFamily="2" charset="-122"/>
              </a:rPr>
              <a:t>ScimaX</a:t>
            </a:r>
            <a:r>
              <a:rPr lang="en-US" sz="1200" dirty="0">
                <a:solidFill>
                  <a:srgbClr val="000000"/>
                </a:solidFill>
                <a:latin typeface="Calibri" panose="020F0502020204030204" pitchFamily="34" charset="0"/>
                <a:ea typeface="DengXian" panose="02010600030101010101" pitchFamily="2" charset="-122"/>
              </a:rPr>
              <a:t> 7T</a:t>
            </a:r>
          </a:p>
          <a:p>
            <a:pPr marL="171450" marR="0" lvl="1" indent="-171450"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Char char="•"/>
              <a:tabLst>
                <a:tab pos="914400" algn="l"/>
              </a:tabLst>
            </a:pPr>
            <a:r>
              <a:rPr lang="en-US" sz="1200" dirty="0">
                <a:solidFill>
                  <a:srgbClr val="000000"/>
                </a:solidFill>
                <a:latin typeface="Calibri" panose="020F0502020204030204" pitchFamily="34" charset="0"/>
                <a:ea typeface="DengXian" panose="02010600030101010101" pitchFamily="2" charset="-122"/>
              </a:rPr>
              <a:t>Negative ion mode, 25 um spatial resolution</a:t>
            </a:r>
          </a:p>
          <a:p>
            <a:pPr marL="171450" marR="0" lvl="1" indent="-171450"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Char char="•"/>
              <a:tabLst>
                <a:tab pos="914400" algn="l"/>
              </a:tabLst>
            </a:pPr>
            <a:r>
              <a:rPr lang="en-US" sz="1200" dirty="0">
                <a:solidFill>
                  <a:srgbClr val="000000"/>
                </a:solidFill>
                <a:latin typeface="Calibri" panose="020F0502020204030204" pitchFamily="34" charset="0"/>
                <a:ea typeface="DengXian" panose="02010600030101010101" pitchFamily="2" charset="-122"/>
              </a:rPr>
              <a:t>DAN parent peak as lock mass</a:t>
            </a:r>
          </a:p>
          <a:p>
            <a:pPr marL="171450" marR="0" lvl="1" indent="-171450">
              <a:spcBef>
                <a:spcPts val="0"/>
              </a:spcBef>
              <a:spcAft>
                <a:spcPts val="0"/>
              </a:spcAft>
              <a:buFont typeface="Arial" panose="020B0604020202020204" pitchFamily="34" charset="0"/>
              <a:buChar char="•"/>
              <a:tabLst>
                <a:tab pos="914400" algn="l"/>
              </a:tabLst>
            </a:pPr>
            <a:endParaRPr lang="en-US" sz="1200" dirty="0">
              <a:solidFill>
                <a:srgbClr val="000000"/>
              </a:solidFill>
              <a:latin typeface="Calibri" panose="020F0502020204030204" pitchFamily="34" charset="0"/>
              <a:ea typeface="DengXian" panose="02010600030101010101" pitchFamily="2" charset="-122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Low Mass: 42 m/z</a:t>
            </a:r>
            <a:endParaRPr lang="en-US" sz="1200" dirty="0">
              <a:effectLst/>
              <a:latin typeface="Calibri" panose="020F0502020204030204" pitchFamily="34" charset="0"/>
              <a:ea typeface="DengXian" panose="02010600030101010101" pitchFamily="2" charset="-122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High Mass: 3000 m/z</a:t>
            </a:r>
            <a:endParaRPr lang="en-US" sz="1200" dirty="0">
              <a:effectLst/>
              <a:latin typeface="Calibri" panose="020F0502020204030204" pitchFamily="34" charset="0"/>
              <a:ea typeface="DengXian" panose="02010600030101010101" pitchFamily="2" charset="-122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Transient Length: 0.21 seconds</a:t>
            </a:r>
            <a:endParaRPr lang="en-US" sz="1200" dirty="0">
              <a:effectLst/>
              <a:latin typeface="Calibri" panose="020F0502020204030204" pitchFamily="34" charset="0"/>
              <a:ea typeface="DengXian" panose="02010600030101010101" pitchFamily="2" charset="-122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Mass Resolution at 150 m/z: 180,000</a:t>
            </a:r>
            <a:endParaRPr lang="en-US" sz="1200" dirty="0">
              <a:effectLst/>
              <a:latin typeface="Calibri" panose="020F0502020204030204" pitchFamily="34" charset="0"/>
              <a:ea typeface="DengXian" panose="02010600030101010101" pitchFamily="2" charset="-122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DengXian" panose="02010600030101010101" pitchFamily="2" charset="-122"/>
              </a:rPr>
              <a:t>Mass Accuracy between 42-800 m/z is &lt;1ppm</a:t>
            </a:r>
          </a:p>
        </p:txBody>
      </p:sp>
    </p:spTree>
    <p:extLst>
      <p:ext uri="{BB962C8B-B14F-4D97-AF65-F5344CB8AC3E}">
        <p14:creationId xmlns:p14="http://schemas.microsoft.com/office/powerpoint/2010/main" val="286511703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A66085AB-046F-47E3-8E76-8C8B2E13D3F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6000" y="157571"/>
            <a:ext cx="11800000" cy="6542857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5B3735CC-1183-41DA-859D-7A7CDE5665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roline (m/z: 114.056052)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2695C071-C97A-4D81-82CC-3DA09E6BE02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00600" y="3074568"/>
            <a:ext cx="7195400" cy="19687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3757440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5C107818-BE79-4FDC-81D8-C6422B3EEA2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6000" y="157571"/>
            <a:ext cx="11800000" cy="6542857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5B3735CC-1183-41DA-859D-7A7CDE5665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hreonine (m/z: 118.050967)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8ECE8DCC-82C8-4788-A913-CD91F7BEEB8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00600" y="3074568"/>
            <a:ext cx="7195400" cy="19687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3718991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584EC85C-EC1E-4A89-9C48-50340B97287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6000" y="157571"/>
            <a:ext cx="11800000" cy="6542857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5B3735CC-1183-41DA-859D-7A7CDE5665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Iso/Leucine (m/z: 130.087352)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131382E8-A916-4042-A2AE-13056B79078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00600" y="3074568"/>
            <a:ext cx="7195400" cy="19687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3488019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0F682FB4-FAAE-4C5C-97FF-16ADD92934C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6000" y="157571"/>
            <a:ext cx="11800000" cy="6542857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5B3735CC-1183-41DA-859D-7A7CDE5665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spartate (m/z: 132.030231)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8CDD4E4C-3222-4780-AFB4-247B6A08CF3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00600" y="3074568"/>
            <a:ext cx="7195400" cy="19687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5071600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4215885-CC4C-4BB5-BF68-8E142D05EE3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6000" y="157571"/>
            <a:ext cx="11800000" cy="6542857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5B3735CC-1183-41DA-859D-7A7CDE5665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alate (m/z: 133.014247)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2E4D9522-D658-49F7-AB80-196BDBA3F80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00600" y="3074568"/>
            <a:ext cx="7195400" cy="19687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8332108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0DE26A5E-F818-4DC7-9436-D75CCD058CC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6000" y="157571"/>
            <a:ext cx="11800000" cy="6542857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5B3735CC-1183-41DA-859D-7A7CDE5665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henylalanine (m/z: 164.071702)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DD143A44-8EAF-4217-A092-197C95EB34F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00600" y="3074568"/>
            <a:ext cx="7195400" cy="19687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07103854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73EB8E2E-B04B-4AF1-8295-EA3C55BC325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6000" y="157571"/>
            <a:ext cx="11800000" cy="6542857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5B3735CC-1183-41DA-859D-7A7CDE5665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Glucose (m/z: 179.056112)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53ACF059-5B7A-4E81-9BA5-DF5E1379E69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00600" y="3074568"/>
            <a:ext cx="7195400" cy="19687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474238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3CC0E5-F720-4EFD-B9B4-920DF02291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Summary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EBDF1E89-6CA6-46F4-8E92-9AE21B78849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74385117"/>
              </p:ext>
            </p:extLst>
          </p:nvPr>
        </p:nvGraphicFramePr>
        <p:xfrm>
          <a:off x="838200" y="2155825"/>
          <a:ext cx="5371431" cy="3393747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321984">
                  <a:extLst>
                    <a:ext uri="{9D8B030D-6E8A-4147-A177-3AD203B41FA5}">
                      <a16:colId xmlns:a16="http://schemas.microsoft.com/office/drawing/2014/main" val="189475374"/>
                    </a:ext>
                  </a:extLst>
                </a:gridCol>
                <a:gridCol w="1321984">
                  <a:extLst>
                    <a:ext uri="{9D8B030D-6E8A-4147-A177-3AD203B41FA5}">
                      <a16:colId xmlns:a16="http://schemas.microsoft.com/office/drawing/2014/main" val="2080771547"/>
                    </a:ext>
                  </a:extLst>
                </a:gridCol>
                <a:gridCol w="1321984">
                  <a:extLst>
                    <a:ext uri="{9D8B030D-6E8A-4147-A177-3AD203B41FA5}">
                      <a16:colId xmlns:a16="http://schemas.microsoft.com/office/drawing/2014/main" val="2095841943"/>
                    </a:ext>
                  </a:extLst>
                </a:gridCol>
                <a:gridCol w="1405479">
                  <a:extLst>
                    <a:ext uri="{9D8B030D-6E8A-4147-A177-3AD203B41FA5}">
                      <a16:colId xmlns:a16="http://schemas.microsoft.com/office/drawing/2014/main" val="785533347"/>
                    </a:ext>
                  </a:extLst>
                </a:gridCol>
              </a:tblGrid>
              <a:tr h="20716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Compound</a:t>
                      </a:r>
                      <a:endParaRPr lang="en-US" sz="11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Theoretical m/z</a:t>
                      </a:r>
                      <a:endParaRPr lang="en-US" sz="11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Detected m/z</a:t>
                      </a:r>
                      <a:endParaRPr lang="en-US" sz="11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Error PPM</a:t>
                      </a:r>
                      <a:endParaRPr lang="en-US" sz="11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3041463"/>
                  </a:ext>
                </a:extLst>
              </a:tr>
              <a:tr h="2414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Acetat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59.01385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59.0138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0.4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2644188560"/>
                  </a:ext>
                </a:extLst>
              </a:tr>
              <a:tr h="2414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Glycin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74.02475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74.0246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-0.8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2479510959"/>
                  </a:ext>
                </a:extLst>
              </a:tr>
              <a:tr h="28969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Pyruvat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87.00876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87.0088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0.4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26429299"/>
                  </a:ext>
                </a:extLst>
              </a:tr>
              <a:tr h="2414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Alanin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88.04040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88.0404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-0.0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2502475021"/>
                  </a:ext>
                </a:extLst>
              </a:tr>
              <a:tr h="2414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Lactat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89.02441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89.0243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-0.5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539036672"/>
                  </a:ext>
                </a:extLst>
              </a:tr>
              <a:tr h="2414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Serin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104.03531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04.0353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0.0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637755107"/>
                  </a:ext>
                </a:extLst>
              </a:tr>
              <a:tr h="2414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Prolin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114.05605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14.0561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0.6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3129844759"/>
                  </a:ext>
                </a:extLst>
              </a:tr>
              <a:tr h="2414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Threonin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118.05096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18.050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-0.5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2264274538"/>
                  </a:ext>
                </a:extLst>
              </a:tr>
              <a:tr h="2414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Iso(leucine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130.08735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130.0873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-0.2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318638421"/>
                  </a:ext>
                </a:extLst>
              </a:tr>
              <a:tr h="2414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Aspartat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132.03023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132.030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-0.2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116396"/>
                  </a:ext>
                </a:extLst>
              </a:tr>
              <a:tr h="2414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Malat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133.01424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133.0141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-0.6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3477248519"/>
                  </a:ext>
                </a:extLst>
              </a:tr>
              <a:tr h="2414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Phenyalanin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164.07170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164.0717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>
                          <a:solidFill>
                            <a:srgbClr val="000000"/>
                          </a:solidFill>
                          <a:effectLst/>
                        </a:rPr>
                        <a:t>0.1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2413624557"/>
                  </a:ext>
                </a:extLst>
              </a:tr>
              <a:tr h="24140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Glucos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79.05611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179.0562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0.8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263022121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886373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1FC6AF2C-0334-4C03-BCAE-7DD0C53DF31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26523"/>
          <a:stretch/>
        </p:blipFill>
        <p:spPr>
          <a:xfrm>
            <a:off x="196000" y="1764635"/>
            <a:ext cx="11800000" cy="480746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7EB04483-60C3-4A11-BBDB-17BEDAD59D8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4144" y="1762351"/>
            <a:ext cx="11801856" cy="4809744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9170BE4F-E058-442A-BF26-856D5A38AD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Results (Control Tissue)</a:t>
            </a:r>
          </a:p>
        </p:txBody>
      </p:sp>
      <p:graphicFrame>
        <p:nvGraphicFramePr>
          <p:cNvPr id="8" name="Table 11">
            <a:extLst>
              <a:ext uri="{FF2B5EF4-FFF2-40B4-BE49-F238E27FC236}">
                <a16:creationId xmlns:a16="http://schemas.microsoft.com/office/drawing/2014/main" id="{CEC3FA36-1F87-4163-A4CA-FBB56E63592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14861363"/>
              </p:ext>
            </p:extLst>
          </p:nvPr>
        </p:nvGraphicFramePr>
        <p:xfrm>
          <a:off x="625643" y="2286003"/>
          <a:ext cx="10924675" cy="2061412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184935">
                  <a:extLst>
                    <a:ext uri="{9D8B030D-6E8A-4147-A177-3AD203B41FA5}">
                      <a16:colId xmlns:a16="http://schemas.microsoft.com/office/drawing/2014/main" val="773564717"/>
                    </a:ext>
                  </a:extLst>
                </a:gridCol>
                <a:gridCol w="2184935">
                  <a:extLst>
                    <a:ext uri="{9D8B030D-6E8A-4147-A177-3AD203B41FA5}">
                      <a16:colId xmlns:a16="http://schemas.microsoft.com/office/drawing/2014/main" val="1697918913"/>
                    </a:ext>
                  </a:extLst>
                </a:gridCol>
                <a:gridCol w="2184935">
                  <a:extLst>
                    <a:ext uri="{9D8B030D-6E8A-4147-A177-3AD203B41FA5}">
                      <a16:colId xmlns:a16="http://schemas.microsoft.com/office/drawing/2014/main" val="2900763870"/>
                    </a:ext>
                  </a:extLst>
                </a:gridCol>
                <a:gridCol w="2184935">
                  <a:extLst>
                    <a:ext uri="{9D8B030D-6E8A-4147-A177-3AD203B41FA5}">
                      <a16:colId xmlns:a16="http://schemas.microsoft.com/office/drawing/2014/main" val="2255922581"/>
                    </a:ext>
                  </a:extLst>
                </a:gridCol>
                <a:gridCol w="2184935">
                  <a:extLst>
                    <a:ext uri="{9D8B030D-6E8A-4147-A177-3AD203B41FA5}">
                      <a16:colId xmlns:a16="http://schemas.microsoft.com/office/drawing/2014/main" val="2782281237"/>
                    </a:ext>
                  </a:extLst>
                </a:gridCol>
              </a:tblGrid>
              <a:tr h="515353"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solidFill>
                          <a:schemeClr val="bg1"/>
                        </a:solidFill>
                        <a:highlight>
                          <a:srgbClr val="000000"/>
                        </a:highlight>
                      </a:endParaRPr>
                    </a:p>
                  </a:txBody>
                  <a:tcPr marL="98735" marR="98735" marT="49367" marB="49367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>
                          <a:solidFill>
                            <a:schemeClr val="bg1"/>
                          </a:solidFill>
                          <a:effectLst/>
                          <a:highlight>
                            <a:srgbClr val="000000"/>
                          </a:highlight>
                        </a:rPr>
                        <a:t>Acetate - m/z 59.003</a:t>
                      </a:r>
                      <a:endParaRPr lang="en-US" sz="800" b="0" i="0" u="none" strike="noStrike" dirty="0">
                        <a:solidFill>
                          <a:schemeClr val="bg1"/>
                        </a:solidFill>
                        <a:effectLst/>
                        <a:highlight>
                          <a:srgbClr val="0000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98735" marR="98735" marT="49367" marB="49367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>
                          <a:solidFill>
                            <a:schemeClr val="bg1"/>
                          </a:solidFill>
                          <a:effectLst/>
                          <a:highlight>
                            <a:srgbClr val="000000"/>
                          </a:highlight>
                        </a:rPr>
                        <a:t>Glycine - m/z 74.024752</a:t>
                      </a:r>
                      <a:endParaRPr lang="en-US" sz="800" b="0" i="0" u="none" strike="noStrike" dirty="0">
                        <a:solidFill>
                          <a:schemeClr val="bg1"/>
                        </a:solidFill>
                        <a:effectLst/>
                        <a:highlight>
                          <a:srgbClr val="0000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98735" marR="98735" marT="49367" marB="49367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>
                          <a:solidFill>
                            <a:schemeClr val="bg1"/>
                          </a:solidFill>
                          <a:effectLst/>
                          <a:highlight>
                            <a:srgbClr val="000000"/>
                          </a:highlight>
                        </a:rPr>
                        <a:t>Pyruvate - m/z 87.00767</a:t>
                      </a:r>
                      <a:endParaRPr lang="en-US" sz="800" b="0" i="0" u="none" strike="noStrike" dirty="0">
                        <a:solidFill>
                          <a:schemeClr val="bg1"/>
                        </a:solidFill>
                        <a:effectLst/>
                        <a:highlight>
                          <a:srgbClr val="0000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98735" marR="98735" marT="49367" marB="49367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>
                          <a:solidFill>
                            <a:schemeClr val="bg1"/>
                          </a:solidFill>
                          <a:effectLst/>
                          <a:highlight>
                            <a:srgbClr val="000000"/>
                          </a:highlight>
                        </a:rPr>
                        <a:t>Alanine - m/z 88.040402</a:t>
                      </a:r>
                      <a:endParaRPr lang="en-US" sz="800" b="0" i="0" u="none" strike="noStrike" dirty="0">
                        <a:solidFill>
                          <a:schemeClr val="bg1"/>
                        </a:solidFill>
                        <a:effectLst/>
                        <a:highlight>
                          <a:srgbClr val="0000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98735" marR="98735" marT="49367" marB="49367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22629075"/>
                  </a:ext>
                </a:extLst>
              </a:tr>
              <a:tr h="515353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>
                          <a:solidFill>
                            <a:schemeClr val="bg1"/>
                          </a:solidFill>
                          <a:effectLst/>
                          <a:highlight>
                            <a:srgbClr val="000000"/>
                          </a:highlight>
                        </a:rPr>
                        <a:t>Lactate - m/z 89.024418</a:t>
                      </a:r>
                      <a:endParaRPr lang="en-US" sz="800" b="0" i="0" u="none" strike="noStrike" dirty="0">
                        <a:solidFill>
                          <a:schemeClr val="bg1"/>
                        </a:solidFill>
                        <a:effectLst/>
                        <a:highlight>
                          <a:srgbClr val="0000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98735" marR="98735" marT="49367" marB="49367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>
                          <a:solidFill>
                            <a:schemeClr val="bg1"/>
                          </a:solidFill>
                          <a:effectLst/>
                          <a:highlight>
                            <a:srgbClr val="000000"/>
                          </a:highlight>
                        </a:rPr>
                        <a:t>Serine - m/z 104.035317</a:t>
                      </a:r>
                      <a:endParaRPr lang="en-US" sz="800" b="0" i="0" u="none" strike="noStrike" dirty="0">
                        <a:solidFill>
                          <a:schemeClr val="bg1"/>
                        </a:solidFill>
                        <a:effectLst/>
                        <a:highlight>
                          <a:srgbClr val="0000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98735" marR="98735" marT="49367" marB="49367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>
                          <a:solidFill>
                            <a:schemeClr val="bg1"/>
                          </a:solidFill>
                          <a:effectLst/>
                          <a:highlight>
                            <a:srgbClr val="000000"/>
                          </a:highlight>
                        </a:rPr>
                        <a:t>Proline - m/z 114.056052</a:t>
                      </a:r>
                      <a:endParaRPr lang="en-US" sz="800" b="0" i="0" u="none" strike="noStrike" dirty="0">
                        <a:solidFill>
                          <a:schemeClr val="bg1"/>
                        </a:solidFill>
                        <a:effectLst/>
                        <a:highlight>
                          <a:srgbClr val="0000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98735" marR="98735" marT="49367" marB="49367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>
                          <a:solidFill>
                            <a:schemeClr val="bg1"/>
                          </a:solidFill>
                          <a:effectLst/>
                          <a:highlight>
                            <a:srgbClr val="000000"/>
                          </a:highlight>
                        </a:rPr>
                        <a:t>Threonine - m/z 118.050967</a:t>
                      </a:r>
                      <a:endParaRPr lang="en-US" sz="800" b="0" i="0" u="none" strike="noStrike" dirty="0">
                        <a:solidFill>
                          <a:schemeClr val="bg1"/>
                        </a:solidFill>
                        <a:effectLst/>
                        <a:highlight>
                          <a:srgbClr val="0000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98735" marR="98735" marT="49367" marB="49367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>
                          <a:solidFill>
                            <a:schemeClr val="bg1"/>
                          </a:solidFill>
                          <a:effectLst/>
                          <a:highlight>
                            <a:srgbClr val="000000"/>
                          </a:highlight>
                        </a:rPr>
                        <a:t>Iso(leucine) - m/z 130.087352</a:t>
                      </a:r>
                      <a:endParaRPr lang="en-US" sz="800" b="0" i="0" u="none" strike="noStrike" dirty="0">
                        <a:solidFill>
                          <a:schemeClr val="bg1"/>
                        </a:solidFill>
                        <a:effectLst/>
                        <a:highlight>
                          <a:srgbClr val="0000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98735" marR="98735" marT="49367" marB="49367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5413571"/>
                  </a:ext>
                </a:extLst>
              </a:tr>
              <a:tr h="515353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>
                          <a:solidFill>
                            <a:schemeClr val="bg1"/>
                          </a:solidFill>
                          <a:effectLst/>
                          <a:highlight>
                            <a:srgbClr val="000000"/>
                          </a:highlight>
                        </a:rPr>
                        <a:t>Aspartate - m/z 132.03031</a:t>
                      </a:r>
                      <a:endParaRPr lang="en-US" sz="800" b="0" i="0" u="none" strike="noStrike" dirty="0">
                        <a:solidFill>
                          <a:schemeClr val="bg1"/>
                        </a:solidFill>
                        <a:effectLst/>
                        <a:highlight>
                          <a:srgbClr val="0000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98735" marR="98735" marT="49367" marB="49367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>
                          <a:solidFill>
                            <a:schemeClr val="bg1"/>
                          </a:solidFill>
                          <a:effectLst/>
                          <a:highlight>
                            <a:srgbClr val="000000"/>
                          </a:highlight>
                        </a:rPr>
                        <a:t>Malate - m/z 133.014247</a:t>
                      </a:r>
                      <a:endParaRPr lang="en-US" sz="800" b="0" i="0" u="none" strike="noStrike" dirty="0">
                        <a:solidFill>
                          <a:schemeClr val="bg1"/>
                        </a:solidFill>
                        <a:effectLst/>
                        <a:highlight>
                          <a:srgbClr val="0000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98735" marR="98735" marT="49367" marB="49367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>
                          <a:solidFill>
                            <a:schemeClr val="bg1"/>
                          </a:solidFill>
                          <a:effectLst/>
                          <a:highlight>
                            <a:srgbClr val="000000"/>
                          </a:highlight>
                        </a:rPr>
                        <a:t>Phenylalanine - m/z 164.071702</a:t>
                      </a:r>
                      <a:endParaRPr lang="en-US" sz="800" b="0" i="0" u="none" strike="noStrike" dirty="0">
                        <a:solidFill>
                          <a:schemeClr val="bg1"/>
                        </a:solidFill>
                        <a:effectLst/>
                        <a:highlight>
                          <a:srgbClr val="0000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98735" marR="98735" marT="49367" marB="49367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>
                          <a:solidFill>
                            <a:schemeClr val="bg1"/>
                          </a:solidFill>
                          <a:effectLst/>
                          <a:highlight>
                            <a:srgbClr val="000000"/>
                          </a:highlight>
                        </a:rPr>
                        <a:t>Glucose - m/z 179.056112</a:t>
                      </a:r>
                      <a:endParaRPr lang="en-US" sz="800" b="0" i="0" u="none" strike="noStrike" dirty="0">
                        <a:solidFill>
                          <a:schemeClr val="bg1"/>
                        </a:solidFill>
                        <a:effectLst/>
                        <a:highlight>
                          <a:srgbClr val="0000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98735" marR="98735" marT="49367" marB="49367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b="0" i="0" u="none" strike="noStrike" dirty="0">
                        <a:solidFill>
                          <a:schemeClr val="bg1"/>
                        </a:solidFill>
                        <a:effectLst/>
                        <a:highlight>
                          <a:srgbClr val="0000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98735" marR="98735" marT="49367" marB="49367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23990587"/>
                  </a:ext>
                </a:extLst>
              </a:tr>
              <a:tr h="515353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b="0" i="0" u="none" strike="noStrike" dirty="0">
                        <a:solidFill>
                          <a:schemeClr val="bg1"/>
                        </a:solidFill>
                        <a:effectLst/>
                        <a:highlight>
                          <a:srgbClr val="0000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98735" marR="98735" marT="49367" marB="49367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b="0" i="0" u="none" strike="noStrike" dirty="0">
                        <a:solidFill>
                          <a:schemeClr val="bg1"/>
                        </a:solidFill>
                        <a:effectLst/>
                        <a:highlight>
                          <a:srgbClr val="000000"/>
                        </a:highlight>
                        <a:latin typeface="Calibri" panose="020F0502020204030204" pitchFamily="34" charset="0"/>
                      </a:endParaRPr>
                    </a:p>
                  </a:txBody>
                  <a:tcPr marL="98735" marR="98735" marT="49367" marB="49367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solidFill>
                          <a:schemeClr val="bg1"/>
                        </a:solidFill>
                        <a:highlight>
                          <a:srgbClr val="000000"/>
                        </a:highlight>
                      </a:endParaRPr>
                    </a:p>
                  </a:txBody>
                  <a:tcPr marL="98735" marR="98735" marT="49367" marB="49367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solidFill>
                          <a:schemeClr val="bg1"/>
                        </a:solidFill>
                        <a:highlight>
                          <a:srgbClr val="000000"/>
                        </a:highlight>
                      </a:endParaRPr>
                    </a:p>
                  </a:txBody>
                  <a:tcPr marL="98735" marR="98735" marT="49367" marB="49367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800" dirty="0">
                        <a:solidFill>
                          <a:schemeClr val="bg1"/>
                        </a:solidFill>
                        <a:highlight>
                          <a:srgbClr val="000000"/>
                        </a:highlight>
                      </a:endParaRPr>
                    </a:p>
                  </a:txBody>
                  <a:tcPr marL="98735" marR="98735" marT="49367" marB="49367" anchor="b">
                    <a:lnL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47893376"/>
                  </a:ext>
                </a:extLst>
              </a:tr>
            </a:tbl>
          </a:graphicData>
        </a:graphic>
      </p:graphicFrame>
      <p:pic>
        <p:nvPicPr>
          <p:cNvPr id="10" name="Picture 9">
            <a:extLst>
              <a:ext uri="{FF2B5EF4-FFF2-40B4-BE49-F238E27FC236}">
                <a16:creationId xmlns:a16="http://schemas.microsoft.com/office/drawing/2014/main" id="{90CC4C76-1CA8-473B-9E5A-0C10315F973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61159" y="4481431"/>
            <a:ext cx="7151284" cy="19566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6822450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F5803F6A-EE0D-4361-B5C0-1B383E7907D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6000" y="157571"/>
            <a:ext cx="11800000" cy="6542857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55479EB3-C810-49A4-9143-5E212E68333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00600" y="2723652"/>
            <a:ext cx="7123210" cy="1948965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5B3735CC-1183-41DA-859D-7A7CDE5665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cetate (m/z: 59.013853)</a:t>
            </a:r>
          </a:p>
        </p:txBody>
      </p:sp>
    </p:spTree>
    <p:extLst>
      <p:ext uri="{BB962C8B-B14F-4D97-AF65-F5344CB8AC3E}">
        <p14:creationId xmlns:p14="http://schemas.microsoft.com/office/powerpoint/2010/main" val="271026044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53171F42-0487-4BB4-B2F5-57225FCAE8E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6000" y="157571"/>
            <a:ext cx="11800000" cy="6542857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5B3735CC-1183-41DA-859D-7A7CDE5665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Glycine (m/z: 74.024752)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BAF0E12D-C618-473F-9495-E30370C29F2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91446" y="3072063"/>
            <a:ext cx="7204554" cy="19712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4165769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ACC43812-C221-4B3F-9DCE-EDC86726036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6000" y="157571"/>
            <a:ext cx="11800000" cy="6542857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5B3735CC-1183-41DA-859D-7A7CDE5665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yruvate (m/z: 87.008768)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EBF49E17-854C-4577-A893-DF9B05CBED5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20761" y="3080084"/>
            <a:ext cx="7175239" cy="19632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5521942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CBD58A31-50D1-444C-BB53-75C3ED66664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6000" y="157571"/>
            <a:ext cx="11800000" cy="6542857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5B3735CC-1183-41DA-859D-7A7CDE5665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lanine (m/z: 88.040402)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AE1D736A-6EDB-4483-9E3B-CC6225C6405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12632" y="3077860"/>
            <a:ext cx="7183368" cy="19654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7221895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C5F39F2-7923-4746-9262-364B3B0D234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6000" y="157571"/>
            <a:ext cx="11800000" cy="6542857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5B3735CC-1183-41DA-859D-7A7CDE5665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Lactate (m/z: 89.024418)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1907EF90-ABA1-4AEE-9F61-1A15B400B58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00600" y="3074568"/>
            <a:ext cx="7195400" cy="19687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5061881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C9CCCB35-4F9E-427C-AD07-D6691619DF4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6000" y="157571"/>
            <a:ext cx="11800000" cy="6542857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5B3735CC-1183-41DA-859D-7A7CDE5665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erine (m/z: 104.035317)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3477990D-6552-4279-8EA2-155DA01DA6D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00600" y="3074568"/>
            <a:ext cx="7195400" cy="19687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878599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Theme">
  <a:themeElements>
    <a:clrScheme name="Blue Warm">
      <a:dk1>
        <a:sysClr val="windowText" lastClr="000000"/>
      </a:dk1>
      <a:lt1>
        <a:sysClr val="window" lastClr="FFFFFF"/>
      </a:lt1>
      <a:dk2>
        <a:srgbClr val="242852"/>
      </a:dk2>
      <a:lt2>
        <a:srgbClr val="ACCBF9"/>
      </a:lt2>
      <a:accent1>
        <a:srgbClr val="4A66AC"/>
      </a:accent1>
      <a:accent2>
        <a:srgbClr val="629DD1"/>
      </a:accent2>
      <a:accent3>
        <a:srgbClr val="297FD5"/>
      </a:accent3>
      <a:accent4>
        <a:srgbClr val="7F8FA9"/>
      </a:accent4>
      <a:accent5>
        <a:srgbClr val="5AA2AE"/>
      </a:accent5>
      <a:accent6>
        <a:srgbClr val="9D90A0"/>
      </a:accent6>
      <a:hlink>
        <a:srgbClr val="9454C3"/>
      </a:hlink>
      <a:folHlink>
        <a:srgbClr val="3EBBF0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86</TotalTime>
  <Words>387</Words>
  <Application>Microsoft Office PowerPoint</Application>
  <PresentationFormat>Widescreen</PresentationFormat>
  <Paragraphs>98</Paragraphs>
  <Slides>1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16</vt:i4>
      </vt:variant>
    </vt:vector>
  </HeadingPairs>
  <TitlesOfParts>
    <vt:vector size="21" baseType="lpstr">
      <vt:lpstr>Arial</vt:lpstr>
      <vt:lpstr>Calibri</vt:lpstr>
      <vt:lpstr>Calibri Light</vt:lpstr>
      <vt:lpstr>Office Theme</vt:lpstr>
      <vt:lpstr>1_Office Theme</vt:lpstr>
      <vt:lpstr>Setup</vt:lpstr>
      <vt:lpstr>Summary</vt:lpstr>
      <vt:lpstr>Results (Control Tissue)</vt:lpstr>
      <vt:lpstr>Acetate (m/z: 59.013853)</vt:lpstr>
      <vt:lpstr>Glycine (m/z: 74.024752)</vt:lpstr>
      <vt:lpstr>Pyruvate (m/z: 87.008768)</vt:lpstr>
      <vt:lpstr>Alanine (m/z: 88.040402)</vt:lpstr>
      <vt:lpstr>Lactate (m/z: 89.024418)</vt:lpstr>
      <vt:lpstr>Serine (m/z: 104.035317)</vt:lpstr>
      <vt:lpstr>Proline (m/z: 114.056052)</vt:lpstr>
      <vt:lpstr>Threonine (m/z: 118.050967)</vt:lpstr>
      <vt:lpstr>Iso/Leucine (m/z: 130.087352)</vt:lpstr>
      <vt:lpstr>Aspartate (m/z: 132.030231)</vt:lpstr>
      <vt:lpstr>Malate (m/z: 133.014247)</vt:lpstr>
      <vt:lpstr>Phenylalanine (m/z: 164.071702)</vt:lpstr>
      <vt:lpstr>Glucose (m/z: 179.056112)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than Yang</dc:creator>
  <cp:lastModifiedBy>Aline</cp:lastModifiedBy>
  <cp:revision>5</cp:revision>
  <dcterms:created xsi:type="dcterms:W3CDTF">2021-05-11T17:45:00Z</dcterms:created>
  <dcterms:modified xsi:type="dcterms:W3CDTF">2021-06-14T06:29:08Z</dcterms:modified>
</cp:coreProperties>
</file>